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26" d="100"/>
          <a:sy n="126" d="100"/>
        </p:scale>
        <p:origin x="-1242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2F457-A68C-480A-8265-9EB01421DA93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DD012-09CA-4D98-B0F7-F9999AF72D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63185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2F457-A68C-480A-8265-9EB01421DA93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DD012-09CA-4D98-B0F7-F9999AF72D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1390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2F457-A68C-480A-8265-9EB01421DA93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DD012-09CA-4D98-B0F7-F9999AF72D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8260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2F457-A68C-480A-8265-9EB01421DA93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DD012-09CA-4D98-B0F7-F9999AF72D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55653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2F457-A68C-480A-8265-9EB01421DA93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DD012-09CA-4D98-B0F7-F9999AF72D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91229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2F457-A68C-480A-8265-9EB01421DA93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DD012-09CA-4D98-B0F7-F9999AF72D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2471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2F457-A68C-480A-8265-9EB01421DA93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DD012-09CA-4D98-B0F7-F9999AF72D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55933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2F457-A68C-480A-8265-9EB01421DA93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DD012-09CA-4D98-B0F7-F9999AF72D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96948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2F457-A68C-480A-8265-9EB01421DA93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DD012-09CA-4D98-B0F7-F9999AF72D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53726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2F457-A68C-480A-8265-9EB01421DA93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DD012-09CA-4D98-B0F7-F9999AF72D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83542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2F457-A68C-480A-8265-9EB01421DA93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1DD012-09CA-4D98-B0F7-F9999AF72D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85529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22F457-A68C-480A-8265-9EB01421DA93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1DD012-09CA-4D98-B0F7-F9999AF72D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55300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566914" y="3905252"/>
            <a:ext cx="1585478" cy="1352548"/>
            <a:chOff x="2081383" y="3443504"/>
            <a:chExt cx="1585478" cy="1352548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5539" b="26653"/>
            <a:stretch/>
          </p:blipFill>
          <p:spPr>
            <a:xfrm>
              <a:off x="2081383" y="3443504"/>
              <a:ext cx="1585478" cy="1352548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2484362" y="3864430"/>
              <a:ext cx="619272" cy="3385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.3N</a:t>
              </a: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142861" y="3645969"/>
              <a:ext cx="619272" cy="3385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solidFill>
                    <a:srgbClr val="6666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.0N</a:t>
              </a:r>
            </a:p>
          </p:txBody>
        </p:sp>
      </p:grpSp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40162" y="5356860"/>
            <a:ext cx="6614160" cy="9677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 rot="16200000">
            <a:off x="942110" y="5683784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prstClr val="black"/>
                </a:solidFill>
                <a:cs typeface="Arial" panose="020B0604020202020204" pitchFamily="34" charset="0"/>
              </a:rPr>
              <a:t>Log</a:t>
            </a:r>
            <a:r>
              <a:rPr lang="en-US" sz="1200" b="1" baseline="-25000" dirty="0">
                <a:solidFill>
                  <a:prstClr val="black"/>
                </a:solidFill>
                <a:cs typeface="Arial" panose="020B0604020202020204" pitchFamily="34" charset="0"/>
              </a:rPr>
              <a:t>2</a:t>
            </a:r>
            <a:r>
              <a:rPr lang="en-US" sz="1200" b="1" dirty="0">
                <a:solidFill>
                  <a:prstClr val="black"/>
                </a:solidFill>
                <a:cs typeface="Arial" panose="020B0604020202020204" pitchFamily="34" charset="0"/>
              </a:rPr>
              <a:t>ratio</a:t>
            </a:r>
          </a:p>
        </p:txBody>
      </p:sp>
      <p:grpSp>
        <p:nvGrpSpPr>
          <p:cNvPr id="9" name="Group 8"/>
          <p:cNvGrpSpPr/>
          <p:nvPr/>
        </p:nvGrpSpPr>
        <p:grpSpPr>
          <a:xfrm>
            <a:off x="8031366" y="5399175"/>
            <a:ext cx="274434" cy="882243"/>
            <a:chOff x="8886758" y="1176666"/>
            <a:chExt cx="274434" cy="882243"/>
          </a:xfrm>
        </p:grpSpPr>
        <p:sp>
          <p:nvSpPr>
            <p:cNvPr id="10" name="TextBox 9"/>
            <p:cNvSpPr txBox="1"/>
            <p:nvPr/>
          </p:nvSpPr>
          <p:spPr>
            <a:xfrm>
              <a:off x="8889162" y="1479288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prstClr val="black"/>
                  </a:solidFill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8886758" y="1176666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prstClr val="black"/>
                  </a:solidFill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8905994" y="1781910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prstClr val="black"/>
                  </a:solidFill>
                  <a:cs typeface="Arial" panose="020B0604020202020204" pitchFamily="34" charset="0"/>
                </a:rPr>
                <a:t>-</a:t>
              </a:r>
            </a:p>
          </p:txBody>
        </p:sp>
      </p:grpSp>
      <p:pic>
        <p:nvPicPr>
          <p:cNvPr id="21" name="Picture 3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5523" r="35081"/>
          <a:stretch/>
        </p:blipFill>
        <p:spPr bwMode="auto">
          <a:xfrm>
            <a:off x="1447353" y="457200"/>
            <a:ext cx="1753047" cy="16796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2" name="TextBox 21"/>
          <p:cNvSpPr txBox="1"/>
          <p:nvPr/>
        </p:nvSpPr>
        <p:spPr>
          <a:xfrm>
            <a:off x="2511800" y="954110"/>
            <a:ext cx="562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.0N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2170299" y="735649"/>
            <a:ext cx="562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.0N</a:t>
            </a:r>
          </a:p>
        </p:txBody>
      </p:sp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40162" y="2156460"/>
            <a:ext cx="6614160" cy="9677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5" name="TextBox 24"/>
          <p:cNvSpPr txBox="1"/>
          <p:nvPr/>
        </p:nvSpPr>
        <p:spPr>
          <a:xfrm rot="16200000">
            <a:off x="942110" y="2461163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prstClr val="black"/>
                </a:solidFill>
                <a:cs typeface="Arial" panose="020B0604020202020204" pitchFamily="34" charset="0"/>
              </a:rPr>
              <a:t>Log</a:t>
            </a:r>
            <a:r>
              <a:rPr lang="en-US" sz="1200" b="1" baseline="-25000" dirty="0">
                <a:solidFill>
                  <a:prstClr val="black"/>
                </a:solidFill>
                <a:cs typeface="Arial" panose="020B0604020202020204" pitchFamily="34" charset="0"/>
              </a:rPr>
              <a:t>2</a:t>
            </a:r>
            <a:r>
              <a:rPr lang="en-US" sz="1200" b="1" dirty="0">
                <a:solidFill>
                  <a:prstClr val="black"/>
                </a:solidFill>
                <a:cs typeface="Arial" panose="020B0604020202020204" pitchFamily="34" charset="0"/>
              </a:rPr>
              <a:t>ratio</a:t>
            </a:r>
          </a:p>
        </p:txBody>
      </p:sp>
      <p:grpSp>
        <p:nvGrpSpPr>
          <p:cNvPr id="26" name="Group 25"/>
          <p:cNvGrpSpPr/>
          <p:nvPr/>
        </p:nvGrpSpPr>
        <p:grpSpPr>
          <a:xfrm>
            <a:off x="8031366" y="2176554"/>
            <a:ext cx="274434" cy="882243"/>
            <a:chOff x="8886758" y="1102963"/>
            <a:chExt cx="274434" cy="882243"/>
          </a:xfrm>
        </p:grpSpPr>
        <p:sp>
          <p:nvSpPr>
            <p:cNvPr id="27" name="TextBox 26"/>
            <p:cNvSpPr txBox="1"/>
            <p:nvPr/>
          </p:nvSpPr>
          <p:spPr>
            <a:xfrm>
              <a:off x="8889162" y="1405585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prstClr val="black"/>
                  </a:solidFill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8886758" y="1102963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prstClr val="black"/>
                  </a:solidFill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8905994" y="1708207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prstClr val="black"/>
                  </a:solidFill>
                  <a:cs typeface="Arial" panose="020B0604020202020204" pitchFamily="34" charset="0"/>
                </a:rPr>
                <a:t>-</a:t>
              </a:r>
            </a:p>
          </p:txBody>
        </p:sp>
      </p:grpSp>
      <p:sp>
        <p:nvSpPr>
          <p:cNvPr id="33" name="TextBox 32"/>
          <p:cNvSpPr txBox="1"/>
          <p:nvPr/>
        </p:nvSpPr>
        <p:spPr>
          <a:xfrm>
            <a:off x="1129685" y="44268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1129685" y="186275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" name="Group 16"/>
          <p:cNvGrpSpPr/>
          <p:nvPr/>
        </p:nvGrpSpPr>
        <p:grpSpPr>
          <a:xfrm>
            <a:off x="4753999" y="381000"/>
            <a:ext cx="2748341" cy="1747277"/>
            <a:chOff x="4753999" y="381000"/>
            <a:chExt cx="2748341" cy="1747277"/>
          </a:xfrm>
        </p:grpSpPr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59140" y="381000"/>
              <a:ext cx="2743200" cy="1507331"/>
            </a:xfrm>
            <a:prstGeom prst="rect">
              <a:avLst/>
            </a:prstGeom>
          </p:spPr>
        </p:pic>
        <p:sp>
          <p:nvSpPr>
            <p:cNvPr id="19" name="TextBox 18"/>
            <p:cNvSpPr txBox="1"/>
            <p:nvPr/>
          </p:nvSpPr>
          <p:spPr>
            <a:xfrm rot="16200000">
              <a:off x="4588564" y="763011"/>
              <a:ext cx="562687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ormal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 rot="16200000">
              <a:off x="4580377" y="1364401"/>
              <a:ext cx="562687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umor</a:t>
              </a:r>
            </a:p>
          </p:txBody>
        </p:sp>
        <p:sp>
          <p:nvSpPr>
            <p:cNvPr id="37" name="Rectangle 36"/>
            <p:cNvSpPr/>
            <p:nvPr/>
          </p:nvSpPr>
          <p:spPr>
            <a:xfrm>
              <a:off x="5489941" y="1820500"/>
              <a:ext cx="1963999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b="1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CLRE1C</a:t>
              </a:r>
              <a:r>
                <a:rPr lang="en-US" sz="14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400" b="1" baseline="30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.656_671del16</a:t>
              </a:r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4757342" y="3664374"/>
            <a:ext cx="2744998" cy="1793331"/>
            <a:chOff x="4523600" y="3664374"/>
            <a:chExt cx="2744998" cy="1793331"/>
          </a:xfrm>
        </p:grpSpPr>
        <p:grpSp>
          <p:nvGrpSpPr>
            <p:cNvPr id="16" name="Group 15"/>
            <p:cNvGrpSpPr/>
            <p:nvPr/>
          </p:nvGrpSpPr>
          <p:grpSpPr>
            <a:xfrm>
              <a:off x="4523600" y="3664374"/>
              <a:ext cx="2744998" cy="1507331"/>
              <a:chOff x="5408402" y="190481"/>
              <a:chExt cx="2744998" cy="1507331"/>
            </a:xfrm>
          </p:grpSpPr>
          <p:pic>
            <p:nvPicPr>
              <p:cNvPr id="13" name="Picture 12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410200" y="190481"/>
                <a:ext cx="2743200" cy="1507331"/>
              </a:xfrm>
              <a:prstGeom prst="rect">
                <a:avLst/>
              </a:prstGeom>
            </p:spPr>
          </p:pic>
          <p:sp>
            <p:nvSpPr>
              <p:cNvPr id="14" name="TextBox 13"/>
              <p:cNvSpPr txBox="1"/>
              <p:nvPr/>
            </p:nvSpPr>
            <p:spPr>
              <a:xfrm rot="16200000">
                <a:off x="5242967" y="542361"/>
                <a:ext cx="562687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ormal</a:t>
                </a: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 rot="16200000">
                <a:off x="5234780" y="1181536"/>
                <a:ext cx="562687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umor</a:t>
                </a:r>
              </a:p>
            </p:txBody>
          </p:sp>
        </p:grpSp>
        <p:sp>
          <p:nvSpPr>
            <p:cNvPr id="38" name="Rectangle 37"/>
            <p:cNvSpPr/>
            <p:nvPr/>
          </p:nvSpPr>
          <p:spPr>
            <a:xfrm>
              <a:off x="5735746" y="5149928"/>
              <a:ext cx="128753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b="1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KBH5</a:t>
              </a:r>
              <a:r>
                <a:rPr lang="en-US" sz="1400" b="1" baseline="30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303Q</a:t>
              </a:r>
            </a:p>
          </p:txBody>
        </p:sp>
      </p:grpSp>
      <p:sp>
        <p:nvSpPr>
          <p:cNvPr id="43" name="TextBox 42"/>
          <p:cNvSpPr txBox="1"/>
          <p:nvPr/>
        </p:nvSpPr>
        <p:spPr>
          <a:xfrm>
            <a:off x="6324600" y="6599802"/>
            <a:ext cx="28200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rrett et al., Supplemental Figure </a:t>
            </a:r>
            <a:r>
              <a:rPr lang="en-US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3620193" y="1066208"/>
            <a:ext cx="52770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T/T</a:t>
            </a:r>
            <a:endParaRPr 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3689122" y="4250974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T</a:t>
            </a:r>
            <a:endParaRPr 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4136555" y="44073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1728923" y="360260"/>
            <a:ext cx="8238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NBC-11</a:t>
            </a:r>
            <a:endParaRPr 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1728923" y="3690552"/>
            <a:ext cx="8322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NBC-12</a:t>
            </a:r>
            <a:endParaRPr 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1129685" y="369055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1129685" y="51816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4136555" y="3690552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077802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38</Words>
  <Application>Microsoft Office PowerPoint</Application>
  <PresentationFormat>On-screen Show (4:3)</PresentationFormat>
  <Paragraphs>3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ayo Clini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T Barrett</dc:creator>
  <cp:lastModifiedBy>Michael T Barrett</cp:lastModifiedBy>
  <cp:revision>4</cp:revision>
  <dcterms:created xsi:type="dcterms:W3CDTF">2017-11-30T23:25:01Z</dcterms:created>
  <dcterms:modified xsi:type="dcterms:W3CDTF">2018-05-04T22:25:42Z</dcterms:modified>
</cp:coreProperties>
</file>